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E9FA88-AC26-467E-A78E-9E622F96BC3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F6DEFC-C6F1-4D4B-9C87-0B76F26478B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675970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C1736-ADCF-46B7-86CE-867E5FC30A5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2603-47FB-410B-9325-5CCCBDC1EA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881634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C1736-ADCF-46B7-86CE-867E5FC30A5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2603-47FB-410B-9325-5CCCBDC1EA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75307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C1736-ADCF-46B7-86CE-867E5FC30A5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2603-47FB-410B-9325-5CCCBDC1EA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890084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C1736-ADCF-46B7-86CE-867E5FC30A5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2603-47FB-410B-9325-5CCCBDC1EA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70405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C1736-ADCF-46B7-86CE-867E5FC30A5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2603-47FB-410B-9325-5CCCBDC1EA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61929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C1736-ADCF-46B7-86CE-867E5FC30A5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2603-47FB-410B-9325-5CCCBDC1EA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60170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C1736-ADCF-46B7-86CE-867E5FC30A5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2603-47FB-410B-9325-5CCCBDC1EA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11275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C1736-ADCF-46B7-86CE-867E5FC30A5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2603-47FB-410B-9325-5CCCBDC1EA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89087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C1736-ADCF-46B7-86CE-867E5FC30A5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2603-47FB-410B-9325-5CCCBDC1EA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75014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C1736-ADCF-46B7-86CE-867E5FC30A5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2603-47FB-410B-9325-5CCCBDC1EA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7562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2C1736-ADCF-46B7-86CE-867E5FC30A5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F2603-47FB-410B-9325-5CCCBDC1EA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25022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2C1736-ADCF-46B7-86CE-867E5FC30A53}" type="datetimeFigureOut">
              <a:rPr lang="zh-TW" altLang="en-US" smtClean="0"/>
              <a:t>2026/3/1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F2603-47FB-410B-9325-5CCCBDC1EAD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37503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標題 3"/>
          <p:cNvSpPr txBox="1">
            <a:spLocks/>
          </p:cNvSpPr>
          <p:nvPr/>
        </p:nvSpPr>
        <p:spPr>
          <a:xfrm>
            <a:off x="0" y="365125"/>
            <a:ext cx="12192000" cy="1325563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endParaRPr lang="zh-TW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標題 3"/>
          <p:cNvSpPr>
            <a:spLocks noGrp="1"/>
          </p:cNvSpPr>
          <p:nvPr>
            <p:ph type="title"/>
          </p:nvPr>
        </p:nvSpPr>
        <p:spPr>
          <a:xfrm>
            <a:off x="263164" y="355947"/>
            <a:ext cx="8518864" cy="1325563"/>
          </a:xfrm>
          <a:solidFill>
            <a:schemeClr val="accent6">
              <a:lumMod val="20000"/>
              <a:lumOff val="80000"/>
            </a:schemeClr>
          </a:solidFill>
        </p:spPr>
        <p:txBody>
          <a:bodyPr>
            <a:noAutofit/>
          </a:bodyPr>
          <a:lstStyle/>
          <a:p>
            <a:r>
              <a:rPr lang="en-US" altLang="zh-TW" sz="2800" b="1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abolic syndrome and high-sensitivity C-reactive protein co-modify the risk of coronary artery calcification</a:t>
            </a:r>
            <a:endParaRPr lang="zh-TW" altLang="en-US" sz="2800" b="1" dirty="0">
              <a:solidFill>
                <a:schemeClr val="accent5">
                  <a:lumMod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內容版面配置區 6"/>
          <p:cNvSpPr>
            <a:spLocks noGrp="1"/>
          </p:cNvSpPr>
          <p:nvPr>
            <p:ph sz="half" idx="1"/>
          </p:nvPr>
        </p:nvSpPr>
        <p:spPr>
          <a:xfrm>
            <a:off x="159470" y="1868599"/>
            <a:ext cx="3542518" cy="4660549"/>
          </a:xfrm>
          <a:solidFill>
            <a:schemeClr val="accent3">
              <a:lumMod val="20000"/>
              <a:lumOff val="80000"/>
            </a:schemeClr>
          </a:solidFill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zh-TW" b="1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thod</a:t>
            </a:r>
          </a:p>
          <a:p>
            <a:pPr marL="0" indent="0">
              <a:buNone/>
            </a:pPr>
            <a:r>
              <a:rPr lang="en-US" altLang="zh-TW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s cross-sectional study included 1948 adults undergoing health checkups and coronary calcium scoring via computed tomography. Participants were grouped by </a:t>
            </a:r>
            <a:r>
              <a:rPr lang="en-US" altLang="zh-TW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S</a:t>
            </a:r>
            <a:r>
              <a:rPr lang="en-US" altLang="zh-TW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tus and </a:t>
            </a:r>
            <a:r>
              <a:rPr lang="en-US" altLang="zh-TW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</a:t>
            </a:r>
            <a:r>
              <a:rPr lang="en-US" altLang="zh-TW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RP levels (&lt;0.3 vs. ≥0.3 mg/</a:t>
            </a:r>
            <a:r>
              <a:rPr lang="en-US" altLang="zh-TW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L</a:t>
            </a:r>
            <a:r>
              <a:rPr lang="en-US" altLang="zh-TW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Multivariate logistic regression analysis was used to evaluate associations between </a:t>
            </a:r>
            <a:r>
              <a:rPr lang="en-US" altLang="zh-TW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S</a:t>
            </a:r>
            <a:r>
              <a:rPr lang="en-US" altLang="zh-TW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TW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</a:t>
            </a:r>
            <a:r>
              <a:rPr lang="en-US" altLang="zh-TW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RP, and CAC, adjusting for age, sex, and clinical variables</a:t>
            </a:r>
          </a:p>
        </p:txBody>
      </p:sp>
      <p:sp>
        <p:nvSpPr>
          <p:cNvPr id="8" name="內容版面配置區 7"/>
          <p:cNvSpPr>
            <a:spLocks noGrp="1"/>
          </p:cNvSpPr>
          <p:nvPr>
            <p:ph sz="half" idx="2"/>
          </p:nvPr>
        </p:nvSpPr>
        <p:spPr>
          <a:xfrm>
            <a:off x="3701988" y="5347336"/>
            <a:ext cx="8226848" cy="1169957"/>
          </a:xfrm>
          <a:solidFill>
            <a:schemeClr val="accent4">
              <a:lumMod val="20000"/>
              <a:lumOff val="80000"/>
            </a:schemeClr>
          </a:solidFill>
          <a:ln>
            <a:solidFill>
              <a:schemeClr val="tx2">
                <a:lumMod val="40000"/>
                <a:lumOff val="60000"/>
              </a:schemeClr>
            </a:solidFill>
          </a:ln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zh-TW" sz="2500" b="1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nclusion</a:t>
            </a:r>
          </a:p>
          <a:p>
            <a:pPr marL="0" indent="0">
              <a:buNone/>
            </a:pPr>
            <a:r>
              <a:rPr lang="en-US" altLang="zh-TW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S</a:t>
            </a:r>
            <a:r>
              <a:rPr lang="en-US" altLang="zh-TW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ed a stronger association with CAC than </a:t>
            </a:r>
            <a:r>
              <a:rPr lang="en-US" altLang="zh-TW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</a:t>
            </a:r>
            <a:r>
              <a:rPr lang="en-US" altLang="zh-TW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RP, while </a:t>
            </a:r>
            <a:r>
              <a:rPr lang="en-US" altLang="zh-TW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</a:t>
            </a:r>
            <a:r>
              <a:rPr lang="en-US" altLang="zh-TW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RP appeared to confer a modest incremental association.</a:t>
            </a:r>
            <a:endParaRPr lang="zh-TW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766074983" descr="C:\Users\Elaine.Scott\Documents\LaTex\____TEST____Frontiers_LaTeX_Templates_V2.5\Frontiers LaTeX (Science, Health and Engineering) V2.5 - with Supplementary material (V1.2)\logo1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90755" y="355947"/>
            <a:ext cx="2501245" cy="1322885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內容版面配置區 6"/>
          <p:cNvSpPr txBox="1">
            <a:spLocks/>
          </p:cNvSpPr>
          <p:nvPr/>
        </p:nvSpPr>
        <p:spPr>
          <a:xfrm>
            <a:off x="3701988" y="1868599"/>
            <a:ext cx="8226848" cy="346688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vert="horz" lIns="91440" tIns="45720" rIns="91440" bIns="45720" rtlCol="0">
            <a:normAutofit fontScale="700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10000"/>
              </a:lnSpc>
              <a:buNone/>
            </a:pPr>
            <a:r>
              <a:rPr lang="en-US" altLang="zh-TW" sz="3600" b="1" dirty="0">
                <a:solidFill>
                  <a:schemeClr val="accent5">
                    <a:lumMod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utcome for CAC</a:t>
            </a:r>
          </a:p>
          <a:p>
            <a:endParaRPr lang="en-US" altLang="zh-TW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TW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TW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TW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TW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TW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TW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TW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zh-TW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altLang="zh-TW" sz="2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 2 adjusted for age and sex (</a:t>
            </a:r>
            <a:r>
              <a:rPr lang="en-US" altLang="zh-TW" sz="23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OR</a:t>
            </a:r>
            <a:r>
              <a:rPr lang="en-US" altLang="zh-TW" sz="2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djusted odd ratio)</a:t>
            </a:r>
          </a:p>
        </p:txBody>
      </p:sp>
      <p:graphicFrame>
        <p:nvGraphicFramePr>
          <p:cNvPr id="17" name="內容版面配置區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66265304"/>
              </p:ext>
            </p:extLst>
          </p:nvPr>
        </p:nvGraphicFramePr>
        <p:xfrm>
          <a:off x="4101807" y="2326965"/>
          <a:ext cx="7328956" cy="256200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20926">
                  <a:extLst>
                    <a:ext uri="{9D8B030D-6E8A-4147-A177-3AD203B41FA5}">
                      <a16:colId xmlns:a16="http://schemas.microsoft.com/office/drawing/2014/main" val="407543246"/>
                    </a:ext>
                  </a:extLst>
                </a:gridCol>
                <a:gridCol w="611071">
                  <a:extLst>
                    <a:ext uri="{9D8B030D-6E8A-4147-A177-3AD203B41FA5}">
                      <a16:colId xmlns:a16="http://schemas.microsoft.com/office/drawing/2014/main" val="575191828"/>
                    </a:ext>
                  </a:extLst>
                </a:gridCol>
                <a:gridCol w="1267692">
                  <a:extLst>
                    <a:ext uri="{9D8B030D-6E8A-4147-A177-3AD203B41FA5}">
                      <a16:colId xmlns:a16="http://schemas.microsoft.com/office/drawing/2014/main" val="1561942880"/>
                    </a:ext>
                  </a:extLst>
                </a:gridCol>
                <a:gridCol w="572947">
                  <a:extLst>
                    <a:ext uri="{9D8B030D-6E8A-4147-A177-3AD203B41FA5}">
                      <a16:colId xmlns:a16="http://schemas.microsoft.com/office/drawing/2014/main" val="2490586523"/>
                    </a:ext>
                  </a:extLst>
                </a:gridCol>
                <a:gridCol w="903317">
                  <a:extLst>
                    <a:ext uri="{9D8B030D-6E8A-4147-A177-3AD203B41FA5}">
                      <a16:colId xmlns:a16="http://schemas.microsoft.com/office/drawing/2014/main" val="3360346518"/>
                    </a:ext>
                  </a:extLst>
                </a:gridCol>
                <a:gridCol w="1267692">
                  <a:extLst>
                    <a:ext uri="{9D8B030D-6E8A-4147-A177-3AD203B41FA5}">
                      <a16:colId xmlns:a16="http://schemas.microsoft.com/office/drawing/2014/main" val="1261283935"/>
                    </a:ext>
                  </a:extLst>
                </a:gridCol>
                <a:gridCol w="685311">
                  <a:extLst>
                    <a:ext uri="{9D8B030D-6E8A-4147-A177-3AD203B41FA5}">
                      <a16:colId xmlns:a16="http://schemas.microsoft.com/office/drawing/2014/main" val="1096047209"/>
                    </a:ext>
                  </a:extLst>
                </a:gridCol>
              </a:tblGrid>
              <a:tr h="41334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TW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ude</a:t>
                      </a:r>
                      <a:endParaRPr lang="zh-TW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 2</a:t>
                      </a:r>
                      <a:endParaRPr lang="zh-TW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7303376"/>
                  </a:ext>
                </a:extLst>
              </a:tr>
              <a:tr h="413341">
                <a:tc>
                  <a:txBody>
                    <a:bodyPr/>
                    <a:lstStyle/>
                    <a:p>
                      <a:endParaRPr lang="zh-TW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b="1" dirty="0" err="1"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OR</a:t>
                      </a:r>
                      <a:endParaRPr lang="zh-TW" sz="16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95% CI</a:t>
                      </a:r>
                      <a:endParaRPr lang="zh-TW" sz="16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b="1" i="1" dirty="0"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</a:t>
                      </a:r>
                      <a:endParaRPr lang="zh-TW" sz="16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aOR*</a:t>
                      </a:r>
                      <a:endParaRPr lang="zh-TW" sz="160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95% CI</a:t>
                      </a:r>
                      <a:endParaRPr lang="zh-TW" sz="16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600" b="1" i="1" dirty="0"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</a:t>
                      </a:r>
                      <a:endParaRPr lang="zh-TW" sz="1600" dirty="0"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509834576"/>
                  </a:ext>
                </a:extLst>
              </a:tr>
              <a:tr h="4133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MetS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−), low </a:t>
                      </a:r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hsCRP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4926144"/>
                  </a:ext>
                </a:extLst>
              </a:tr>
              <a:tr h="4133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MetS(−), high hsCRP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24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0.924 – 1.68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0.14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53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067 – 2.21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0.021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994918982"/>
                  </a:ext>
                </a:extLst>
              </a:tr>
              <a:tr h="4133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MetS(+), low hsCRP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.69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.007 – 3.60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99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426 – 2.79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415479052"/>
                  </a:ext>
                </a:extLst>
              </a:tr>
              <a:tr h="41334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MetS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+), high </a:t>
                      </a:r>
                      <a:r>
                        <a:rPr lang="en-US" sz="1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hsCRP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.126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381 – 3.27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.392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470 – 3.89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&lt;0.001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368931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83424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84</Words>
  <Application>Microsoft Office PowerPoint</Application>
  <PresentationFormat>寬螢幕</PresentationFormat>
  <Paragraphs>47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佈景主題</vt:lpstr>
      <vt:lpstr>Metabolic syndrome and high-sensitivity C-reactive protein co-modify the risk of coronary artery calcific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tabolic syndrome and high-sensitivity C-reactive protein co-modify the risk of coronary artery calcification</dc:title>
  <dc:creator>user</dc:creator>
  <cp:lastModifiedBy>重寬 吳</cp:lastModifiedBy>
  <cp:revision>6</cp:revision>
  <dcterms:created xsi:type="dcterms:W3CDTF">2026-03-09T06:16:19Z</dcterms:created>
  <dcterms:modified xsi:type="dcterms:W3CDTF">2026-03-10T10:36:14Z</dcterms:modified>
</cp:coreProperties>
</file>